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4" r:id="rId2"/>
  </p:sldIdLst>
  <p:sldSz cx="23760113" cy="13698538"/>
  <p:notesSz cx="6858000" cy="9144000"/>
  <p:defaultTextStyle>
    <a:defPPr>
      <a:defRPr lang="ja-JP"/>
    </a:defPPr>
    <a:lvl1pPr marL="0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1pPr>
    <a:lvl2pPr marL="898992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2pPr>
    <a:lvl3pPr marL="1797985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3pPr>
    <a:lvl4pPr marL="2696977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4pPr>
    <a:lvl5pPr marL="3595969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5pPr>
    <a:lvl6pPr marL="4494962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6pPr>
    <a:lvl7pPr marL="5393954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7pPr>
    <a:lvl8pPr marL="6292947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8pPr>
    <a:lvl9pPr marL="7191939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5" userDrawn="1">
          <p15:clr>
            <a:srgbClr val="A4A3A4"/>
          </p15:clr>
        </p15:guide>
        <p15:guide id="2" pos="6026" userDrawn="1">
          <p15:clr>
            <a:srgbClr val="A4A3A4"/>
          </p15:clr>
        </p15:guide>
        <p15:guide id="3" pos="2401" userDrawn="1">
          <p15:clr>
            <a:srgbClr val="A4A3A4"/>
          </p15:clr>
        </p15:guide>
        <p15:guide id="4" pos="11416" userDrawn="1">
          <p15:clr>
            <a:srgbClr val="A4A3A4"/>
          </p15:clr>
        </p15:guide>
        <p15:guide id="5" orient="horz" pos="459" userDrawn="1">
          <p15:clr>
            <a:srgbClr val="A4A3A4"/>
          </p15:clr>
        </p15:guide>
        <p15:guide id="6" orient="horz" pos="7626" userDrawn="1">
          <p15:clr>
            <a:srgbClr val="A4A3A4"/>
          </p15:clr>
        </p15:guide>
        <p15:guide id="7" pos="1224" userDrawn="1">
          <p15:clr>
            <a:srgbClr val="A4A3A4"/>
          </p15:clr>
        </p15:guide>
        <p15:guide id="8" pos="6962" userDrawn="1">
          <p15:clr>
            <a:srgbClr val="A4A3A4"/>
          </p15:clr>
        </p15:guide>
        <p15:guide id="9" orient="horz" pos="3566" userDrawn="1">
          <p15:clr>
            <a:srgbClr val="A4A3A4"/>
          </p15:clr>
        </p15:guide>
        <p15:guide id="10" orient="horz" pos="431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kayama Izuma" initials="NI" lastIdx="22" clrIdx="0">
    <p:extLst>
      <p:ext uri="{19B8F6BF-5375-455C-9EA6-DF929625EA0E}">
        <p15:presenceInfo xmlns:p15="http://schemas.microsoft.com/office/powerpoint/2012/main" userId="57dc3945d2166f67" providerId="Windows Live"/>
      </p:ext>
    </p:extLst>
  </p:cmAuthor>
  <p:cmAuthor id="2" name="下嵜啓太郎" initials="下嵜啓太郎" lastIdx="8" clrIdx="1">
    <p:extLst>
      <p:ext uri="{19B8F6BF-5375-455C-9EA6-DF929625EA0E}">
        <p15:presenceInfo xmlns:p15="http://schemas.microsoft.com/office/powerpoint/2012/main" userId="759013536612368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52B38"/>
    <a:srgbClr val="005493"/>
    <a:srgbClr val="D9DEED"/>
    <a:srgbClr val="D9DE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17292A2E-F333-43FB-9621-5CBBE7FDCDCB}" styleName="淡色スタイル 2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856"/>
    <p:restoredTop sz="89439"/>
  </p:normalViewPr>
  <p:slideViewPr>
    <p:cSldViewPr snapToGrid="0" snapToObjects="1" showGuides="1">
      <p:cViewPr varScale="1">
        <p:scale>
          <a:sx n="69" d="100"/>
          <a:sy n="69" d="100"/>
        </p:scale>
        <p:origin x="2104" y="216"/>
      </p:cViewPr>
      <p:guideLst>
        <p:guide orient="horz" pos="4315"/>
        <p:guide pos="6026"/>
        <p:guide pos="2401"/>
        <p:guide pos="11416"/>
        <p:guide orient="horz" pos="459"/>
        <p:guide orient="horz" pos="7626"/>
        <p:guide pos="1224"/>
        <p:guide pos="6962"/>
        <p:guide orient="horz" pos="3566"/>
        <p:guide orient="horz" pos="43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A36AEA-D790-F74D-BC9D-BF7A4DB89FE8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752475" y="1143000"/>
            <a:ext cx="5353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412144-BE04-BB46-BAF5-2B46214D0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0002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1pPr>
    <a:lvl2pPr marL="898992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2pPr>
    <a:lvl3pPr marL="1797985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3pPr>
    <a:lvl4pPr marL="2696977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4pPr>
    <a:lvl5pPr marL="3595969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5pPr>
    <a:lvl6pPr marL="4494962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6pPr>
    <a:lvl7pPr marL="5393954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7pPr>
    <a:lvl8pPr marL="6292947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8pPr>
    <a:lvl9pPr marL="7191939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236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 </a:t>
            </a:r>
            <a:r>
              <a:rPr kumimoji="1" lang="en-US" altLang="ja-JP" sz="236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aplan–Meier estimates of overall survival according to the </a:t>
            </a:r>
            <a:r>
              <a:rPr kumimoji="1" lang="en-US" altLang="ja-JP" sz="236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JFCR clinical prognostic </a:t>
            </a:r>
            <a:r>
              <a:rPr kumimoji="1" lang="en-US" altLang="ja-JP" sz="236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dex in HER2-positive (a) and -negative (b) gastric cancer.</a:t>
            </a:r>
            <a:endParaRPr kumimoji="1" lang="ja-JP" altLang="ja-JP" sz="236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412144-BE04-BB46-BAF5-2B46214D041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200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245413-6788-2B4C-9373-C47D59752E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970014" y="2241868"/>
            <a:ext cx="17820085" cy="4769121"/>
          </a:xfrm>
        </p:spPr>
        <p:txBody>
          <a:bodyPr anchor="b"/>
          <a:lstStyle>
            <a:lvl1pPr algn="ctr">
              <a:defRPr sz="11693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E7B1C56-EA5A-6C43-96D4-E0D7C48A6C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970014" y="7194904"/>
            <a:ext cx="17820085" cy="3307308"/>
          </a:xfrm>
        </p:spPr>
        <p:txBody>
          <a:bodyPr/>
          <a:lstStyle>
            <a:lvl1pPr marL="0" indent="0" algn="ctr">
              <a:buNone/>
              <a:defRPr sz="4677"/>
            </a:lvl1pPr>
            <a:lvl2pPr marL="890991" indent="0" algn="ctr">
              <a:buNone/>
              <a:defRPr sz="3898"/>
            </a:lvl2pPr>
            <a:lvl3pPr marL="1781983" indent="0" algn="ctr">
              <a:buNone/>
              <a:defRPr sz="3508"/>
            </a:lvl3pPr>
            <a:lvl4pPr marL="2672974" indent="0" algn="ctr">
              <a:buNone/>
              <a:defRPr sz="3118"/>
            </a:lvl4pPr>
            <a:lvl5pPr marL="3563965" indent="0" algn="ctr">
              <a:buNone/>
              <a:defRPr sz="3118"/>
            </a:lvl5pPr>
            <a:lvl6pPr marL="4454957" indent="0" algn="ctr">
              <a:buNone/>
              <a:defRPr sz="3118"/>
            </a:lvl6pPr>
            <a:lvl7pPr marL="5345948" indent="0" algn="ctr">
              <a:buNone/>
              <a:defRPr sz="3118"/>
            </a:lvl7pPr>
            <a:lvl8pPr marL="6236940" indent="0" algn="ctr">
              <a:buNone/>
              <a:defRPr sz="3118"/>
            </a:lvl8pPr>
            <a:lvl9pPr marL="7127931" indent="0" algn="ctr">
              <a:buNone/>
              <a:defRPr sz="3118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25B8E8-48F3-FE45-A259-3007FF006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5450B2-DF15-204B-97B7-45AEB3FA4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499627-4C77-C042-9C33-49D598DD2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880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28B38F-8A53-2146-822C-03F70A5F6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F0F4321-DD1D-AA4D-B2D5-6141788C05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AC2B8B-F3EA-EF47-9FD2-2E24AF490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DA0236-8C8E-C445-AFE3-853F553D2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D5E371-474A-9B4D-AED5-E2D9AA392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3693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DF0D98B-D173-7249-A791-B2C39DFBDE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7003331" y="729320"/>
            <a:ext cx="5123274" cy="1160887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126A16C-A007-EA45-BD9A-C44C5D04AC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633508" y="729320"/>
            <a:ext cx="15072822" cy="1160887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84D828-113E-5741-A902-231E7BCC9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18295A-419C-DB4A-8A51-AF976B52D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B360BD-DD90-5747-B960-9AFCD1450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311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0995B1-3E8A-5444-AD0D-8226CBF32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518AB91-6F55-8747-A37A-39E5967F71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DD9E7F-1BC1-C244-91AA-F4F9B250E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D9C338-FA7D-2C4A-A2DD-F0B6ED2D9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AEEED8-91AB-C74C-AEAC-F5042061A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728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D99A0D-4717-0A46-A966-1FEC849848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1133" y="3415128"/>
            <a:ext cx="20493097" cy="5698210"/>
          </a:xfrm>
        </p:spPr>
        <p:txBody>
          <a:bodyPr anchor="b"/>
          <a:lstStyle>
            <a:lvl1pPr>
              <a:defRPr sz="11693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C5AC2D5-DC25-FA40-9D90-B6CDE4477F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21133" y="9167245"/>
            <a:ext cx="20493097" cy="2996554"/>
          </a:xfrm>
        </p:spPr>
        <p:txBody>
          <a:bodyPr/>
          <a:lstStyle>
            <a:lvl1pPr marL="0" indent="0">
              <a:buNone/>
              <a:defRPr sz="4677">
                <a:solidFill>
                  <a:schemeClr val="tx1">
                    <a:tint val="75000"/>
                  </a:schemeClr>
                </a:solidFill>
              </a:defRPr>
            </a:lvl1pPr>
            <a:lvl2pPr marL="890991" indent="0">
              <a:buNone/>
              <a:defRPr sz="3898">
                <a:solidFill>
                  <a:schemeClr val="tx1">
                    <a:tint val="75000"/>
                  </a:schemeClr>
                </a:solidFill>
              </a:defRPr>
            </a:lvl2pPr>
            <a:lvl3pPr marL="1781983" indent="0">
              <a:buNone/>
              <a:defRPr sz="3508">
                <a:solidFill>
                  <a:schemeClr val="tx1">
                    <a:tint val="75000"/>
                  </a:schemeClr>
                </a:solidFill>
              </a:defRPr>
            </a:lvl3pPr>
            <a:lvl4pPr marL="2672974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4pPr>
            <a:lvl5pPr marL="3563965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5pPr>
            <a:lvl6pPr marL="4454957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6pPr>
            <a:lvl7pPr marL="5345948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7pPr>
            <a:lvl8pPr marL="6236940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8pPr>
            <a:lvl9pPr marL="7127931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C3CFF1-D0CE-524A-8AB7-32AADEFD0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2E143D-7B5A-1C48-91ED-9BEE292B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8007CA-3D6A-1B44-9F59-0AE01DCC9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659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FA2F9B-A514-1948-8ED6-5243ABD767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F3B15E9-0B49-A846-91C8-7B236CD099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633508" y="3646601"/>
            <a:ext cx="10098048" cy="8691597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39329E0-7B91-5946-8C5B-E5F6313B9E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2028557" y="3646601"/>
            <a:ext cx="10098048" cy="8691597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A2B9979-EC31-D941-B991-28A6E9A6F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4A55BD-BEC8-164F-B6C0-DBA18B3FC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8BC9221-85BA-2B49-AD36-C7A4CCB39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0005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98DB9F-BD80-384A-B4F9-8C365683D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6603" y="729325"/>
            <a:ext cx="20493097" cy="2647751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0354C6C-503D-FE4B-BCB6-963DAB6E21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36605" y="3358045"/>
            <a:ext cx="10051641" cy="1645726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DFC96E3-8B8B-194C-AA50-4114777A9F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636605" y="5003772"/>
            <a:ext cx="10051641" cy="735979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F559E01-1877-9846-A63A-7C4A283013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12028557" y="3358045"/>
            <a:ext cx="10101143" cy="1645726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D1606AD-078C-1A4C-82A9-69B000CDF2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12028557" y="5003772"/>
            <a:ext cx="10101143" cy="735979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5E94413-0DA0-604E-9AC6-13C80C991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30B1DA5-9646-5A48-93AA-0AE615C26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73432D8-7D56-2944-8FEA-04F30B372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596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F7D4ED-8889-1941-A39E-E6BCC173FB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FD3F1BF-5DBF-A640-95E3-BF2C523A3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592A65A-B585-0243-9CEE-F4C3DF6AA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101D531-BC13-EB4C-9687-45480C03D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4027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3CAA49B-321E-6644-A136-D465EB4AE8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D96588C-8889-BF4F-BE08-241C64154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5DA4F96-1DD4-CA4D-B323-6C0010528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921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86B29B-2BC8-FB48-B02F-1DF798A81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6606" y="913236"/>
            <a:ext cx="7663254" cy="3196326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6E6EF6A-6A84-8347-A36E-EA1B9D8CC1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101143" y="1972341"/>
            <a:ext cx="12028557" cy="9734841"/>
          </a:xfrm>
        </p:spPr>
        <p:txBody>
          <a:bodyPr/>
          <a:lstStyle>
            <a:lvl1pPr>
              <a:defRPr sz="6236"/>
            </a:lvl1pPr>
            <a:lvl2pPr>
              <a:defRPr sz="5457"/>
            </a:lvl2pPr>
            <a:lvl3pPr>
              <a:defRPr sz="4677"/>
            </a:lvl3pPr>
            <a:lvl4pPr>
              <a:defRPr sz="3898"/>
            </a:lvl4pPr>
            <a:lvl5pPr>
              <a:defRPr sz="3898"/>
            </a:lvl5pPr>
            <a:lvl6pPr>
              <a:defRPr sz="3898"/>
            </a:lvl6pPr>
            <a:lvl7pPr>
              <a:defRPr sz="3898"/>
            </a:lvl7pPr>
            <a:lvl8pPr>
              <a:defRPr sz="3898"/>
            </a:lvl8pPr>
            <a:lvl9pPr>
              <a:defRPr sz="3898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F5E05A8-DCB7-814E-9F90-197C62983C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636606" y="4109561"/>
            <a:ext cx="7663254" cy="7613471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FEE2390-36B8-4E4B-B50D-A32DDA256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4BE7513-43CA-7948-9E0D-830153426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E36DD5-DF0C-8648-BDEC-65AFF2FFD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9921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742DBD-157F-BE49-88D3-986DDD12C5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6606" y="913236"/>
            <a:ext cx="7663254" cy="3196326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B2C6636-8F7E-FA44-AB01-2C1007A7F5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10101143" y="1972341"/>
            <a:ext cx="12028557" cy="9734841"/>
          </a:xfrm>
        </p:spPr>
        <p:txBody>
          <a:bodyPr/>
          <a:lstStyle>
            <a:lvl1pPr marL="0" indent="0">
              <a:buNone/>
              <a:defRPr sz="6236"/>
            </a:lvl1pPr>
            <a:lvl2pPr marL="890991" indent="0">
              <a:buNone/>
              <a:defRPr sz="5457"/>
            </a:lvl2pPr>
            <a:lvl3pPr marL="1781983" indent="0">
              <a:buNone/>
              <a:defRPr sz="4677"/>
            </a:lvl3pPr>
            <a:lvl4pPr marL="2672974" indent="0">
              <a:buNone/>
              <a:defRPr sz="3898"/>
            </a:lvl4pPr>
            <a:lvl5pPr marL="3563965" indent="0">
              <a:buNone/>
              <a:defRPr sz="3898"/>
            </a:lvl5pPr>
            <a:lvl6pPr marL="4454957" indent="0">
              <a:buNone/>
              <a:defRPr sz="3898"/>
            </a:lvl6pPr>
            <a:lvl7pPr marL="5345948" indent="0">
              <a:buNone/>
              <a:defRPr sz="3898"/>
            </a:lvl7pPr>
            <a:lvl8pPr marL="6236940" indent="0">
              <a:buNone/>
              <a:defRPr sz="3898"/>
            </a:lvl8pPr>
            <a:lvl9pPr marL="7127931" indent="0">
              <a:buNone/>
              <a:defRPr sz="3898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63BC946-7D0D-994A-A1DD-7ED3C02B97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636606" y="4109561"/>
            <a:ext cx="7663254" cy="7613471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23FF658-7A1C-0546-A39F-B376438F3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72B273-AC43-AD46-BC7E-134FD309E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5CEFA7-62A9-0A49-A839-2FAA545FE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532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4C82FAC-8691-D148-8E09-B49F46EBD7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3508" y="729325"/>
            <a:ext cx="20493097" cy="2647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8436E9F-9649-D64D-83CB-0D39C8F1AA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33508" y="3646601"/>
            <a:ext cx="20493097" cy="86915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AFE54B-F4D3-494D-9F02-C020FF4B3E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633508" y="12696520"/>
            <a:ext cx="5346025" cy="729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39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fld id="{6C04196D-1171-3B4A-BAE1-6B6D8949F670}" type="datetimeFigureOut">
              <a:rPr lang="ja-JP" altLang="en-US" smtClean="0"/>
              <a:pPr/>
              <a:t>2021/6/17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A2CF07-A504-0E44-B83D-839D090A74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7870538" y="12696520"/>
            <a:ext cx="8019038" cy="729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39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9E7CF3-FE54-2441-8A09-BA3C3D0A6E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6780580" y="12696520"/>
            <a:ext cx="5346025" cy="729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39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fld id="{97FE01E6-B555-7547-BEFB-252F8AE8412B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59875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781983" rtl="0" eaLnBrk="1" latinLnBrk="0" hangingPunct="1">
        <a:lnSpc>
          <a:spcPct val="90000"/>
        </a:lnSpc>
        <a:spcBef>
          <a:spcPct val="0"/>
        </a:spcBef>
        <a:buNone/>
        <a:defRPr kumimoji="1" sz="8575" b="1" kern="1200">
          <a:solidFill>
            <a:schemeClr val="accent4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1pPr>
    </p:titleStyle>
    <p:bodyStyle>
      <a:lvl1pPr marL="445496" indent="-445496" algn="l" defTabSz="1781983" rtl="0" eaLnBrk="1" latinLnBrk="0" hangingPunct="1">
        <a:lnSpc>
          <a:spcPct val="90000"/>
        </a:lnSpc>
        <a:spcBef>
          <a:spcPts val="1949"/>
        </a:spcBef>
        <a:buFont typeface="Arial" panose="020B0604020202020204" pitchFamily="34" charset="0"/>
        <a:buChar char="•"/>
        <a:defRPr kumimoji="1" sz="5457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1pPr>
      <a:lvl2pPr marL="133648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4677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2pPr>
      <a:lvl3pPr marL="2227478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898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3pPr>
      <a:lvl4pPr marL="3118470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4pPr>
      <a:lvl5pPr marL="4009461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5pPr>
      <a:lvl6pPr marL="4900452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791444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682435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57342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1pPr>
      <a:lvl2pPr marL="890991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2pPr>
      <a:lvl3pPr marL="1781983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3pPr>
      <a:lvl4pPr marL="2672974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4pPr>
      <a:lvl5pPr marL="3563965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5pPr>
      <a:lvl6pPr marL="4454957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345948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236940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127931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40F26D30-DDA0-3947-9D00-E11AA55943D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830" t="2026" r="3711" b="15190"/>
          <a:stretch/>
        </p:blipFill>
        <p:spPr>
          <a:xfrm>
            <a:off x="11087378" y="728663"/>
            <a:ext cx="7283123" cy="497882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C6C98CA5-243E-FC42-B132-0BD504BCB6E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217" t="2246" r="3808" b="16588"/>
          <a:stretch/>
        </p:blipFill>
        <p:spPr>
          <a:xfrm>
            <a:off x="1943099" y="728663"/>
            <a:ext cx="7360841" cy="4963327"/>
          </a:xfrm>
          <a:prstGeom prst="rect">
            <a:avLst/>
          </a:prstGeom>
        </p:spPr>
      </p:pic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D36BF87F-3129-BD4F-BB88-210EFCCC70B0}"/>
              </a:ext>
            </a:extLst>
          </p:cNvPr>
          <p:cNvSpPr txBox="1"/>
          <p:nvPr/>
        </p:nvSpPr>
        <p:spPr>
          <a:xfrm>
            <a:off x="1254821" y="78495"/>
            <a:ext cx="700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HGMaruGothicMPRO" panose="020F0600000000000000" pitchFamily="34" charset="-128"/>
                <a:cs typeface="Arial" panose="020B0604020202020204" pitchFamily="34" charset="0"/>
              </a:rPr>
              <a:t>a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HGMaruGothicMPRO" panose="020F06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47" name="テキスト ボックス 346">
            <a:extLst>
              <a:ext uri="{FF2B5EF4-FFF2-40B4-BE49-F238E27FC236}">
                <a16:creationId xmlns:a16="http://schemas.microsoft.com/office/drawing/2014/main" id="{B9C4BD72-D963-F54D-A052-3585287284B2}"/>
              </a:ext>
            </a:extLst>
          </p:cNvPr>
          <p:cNvSpPr txBox="1"/>
          <p:nvPr/>
        </p:nvSpPr>
        <p:spPr>
          <a:xfrm>
            <a:off x="10173044" y="78495"/>
            <a:ext cx="700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HGMaruGothicMPRO" panose="020F0600000000000000" pitchFamily="34" charset="-128"/>
                <a:cs typeface="Arial" panose="020B0604020202020204" pitchFamily="34" charset="0"/>
              </a:rPr>
              <a:t>b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HGMaruGothicMPRO" panose="020F0600000000000000" pitchFamily="34" charset="-128"/>
              <a:cs typeface="Arial" panose="020B0604020202020204" pitchFamily="34" charset="0"/>
            </a:endParaRPr>
          </a:p>
        </p:txBody>
      </p:sp>
      <p:grpSp>
        <p:nvGrpSpPr>
          <p:cNvPr id="83" name="グループ化 82">
            <a:extLst>
              <a:ext uri="{FF2B5EF4-FFF2-40B4-BE49-F238E27FC236}">
                <a16:creationId xmlns:a16="http://schemas.microsoft.com/office/drawing/2014/main" id="{4DBCE66C-43D4-9B4B-A5E8-59C673861A05}"/>
              </a:ext>
            </a:extLst>
          </p:cNvPr>
          <p:cNvGrpSpPr/>
          <p:nvPr/>
        </p:nvGrpSpPr>
        <p:grpSpPr>
          <a:xfrm>
            <a:off x="1198696" y="559386"/>
            <a:ext cx="8554801" cy="5685588"/>
            <a:chOff x="1198696" y="559386"/>
            <a:chExt cx="8554801" cy="5685588"/>
          </a:xfrm>
        </p:grpSpPr>
        <p:grpSp>
          <p:nvGrpSpPr>
            <p:cNvPr id="84" name="グループ化 83">
              <a:extLst>
                <a:ext uri="{FF2B5EF4-FFF2-40B4-BE49-F238E27FC236}">
                  <a16:creationId xmlns:a16="http://schemas.microsoft.com/office/drawing/2014/main" id="{550C3F3F-1CEF-1442-8D25-9A1CF5245A8E}"/>
                </a:ext>
              </a:extLst>
            </p:cNvPr>
            <p:cNvGrpSpPr/>
            <p:nvPr/>
          </p:nvGrpSpPr>
          <p:grpSpPr>
            <a:xfrm>
              <a:off x="1587536" y="728662"/>
              <a:ext cx="8165961" cy="5516312"/>
              <a:chOff x="1587536" y="728662"/>
              <a:chExt cx="8165961" cy="5516312"/>
            </a:xfrm>
          </p:grpSpPr>
          <p:grpSp>
            <p:nvGrpSpPr>
              <p:cNvPr id="91" name="グループ化 90">
                <a:extLst>
                  <a:ext uri="{FF2B5EF4-FFF2-40B4-BE49-F238E27FC236}">
                    <a16:creationId xmlns:a16="http://schemas.microsoft.com/office/drawing/2014/main" id="{A0971383-1117-9840-B3F5-C836CCD74D58}"/>
                  </a:ext>
                </a:extLst>
              </p:cNvPr>
              <p:cNvGrpSpPr/>
              <p:nvPr/>
            </p:nvGrpSpPr>
            <p:grpSpPr>
              <a:xfrm>
                <a:off x="1856217" y="728662"/>
                <a:ext cx="7699076" cy="5100637"/>
                <a:chOff x="1878266" y="783771"/>
                <a:chExt cx="6812280" cy="4520862"/>
              </a:xfrm>
            </p:grpSpPr>
            <p:grpSp>
              <p:nvGrpSpPr>
                <p:cNvPr id="99" name="グループ化 98">
                  <a:extLst>
                    <a:ext uri="{FF2B5EF4-FFF2-40B4-BE49-F238E27FC236}">
                      <a16:creationId xmlns:a16="http://schemas.microsoft.com/office/drawing/2014/main" id="{47C87D98-612A-D342-89B6-6FC42BF970FC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6812280" cy="4520862"/>
                  <a:chOff x="1878266" y="776087"/>
                  <a:chExt cx="6812280" cy="4520862"/>
                </a:xfrm>
              </p:grpSpPr>
              <p:cxnSp>
                <p:nvCxnSpPr>
                  <p:cNvPr id="106" name="直線コネクタ 105">
                    <a:extLst>
                      <a:ext uri="{FF2B5EF4-FFF2-40B4-BE49-F238E27FC236}">
                        <a16:creationId xmlns:a16="http://schemas.microsoft.com/office/drawing/2014/main" id="{FF043BFE-3D77-7C40-8893-847FF16B03F1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5170949"/>
                    <a:ext cx="681228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" name="直線コネクタ 106">
                    <a:extLst>
                      <a:ext uri="{FF2B5EF4-FFF2-40B4-BE49-F238E27FC236}">
                        <a16:creationId xmlns:a16="http://schemas.microsoft.com/office/drawing/2014/main" id="{62E7BB90-710E-6541-942D-E06920DDABB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2481" y="776087"/>
                    <a:ext cx="0" cy="45208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" name="直線コネクタ 107">
                    <a:extLst>
                      <a:ext uri="{FF2B5EF4-FFF2-40B4-BE49-F238E27FC236}">
                        <a16:creationId xmlns:a16="http://schemas.microsoft.com/office/drawing/2014/main" id="{205830C9-12F3-F747-80F9-A27AA2EAB6CF}"/>
                      </a:ext>
                    </a:extLst>
                  </p:cNvPr>
                  <p:cNvCxnSpPr/>
                  <p:nvPr/>
                </p:nvCxnSpPr>
                <p:spPr>
                  <a:xfrm>
                    <a:off x="2631047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" name="直線コネクタ 108">
                    <a:extLst>
                      <a:ext uri="{FF2B5EF4-FFF2-40B4-BE49-F238E27FC236}">
                        <a16:creationId xmlns:a16="http://schemas.microsoft.com/office/drawing/2014/main" id="{B97307D5-9A0A-FD4A-A14B-0D4296B1F33C}"/>
                      </a:ext>
                    </a:extLst>
                  </p:cNvPr>
                  <p:cNvCxnSpPr/>
                  <p:nvPr/>
                </p:nvCxnSpPr>
                <p:spPr>
                  <a:xfrm>
                    <a:off x="3279613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" name="直線コネクタ 109">
                    <a:extLst>
                      <a:ext uri="{FF2B5EF4-FFF2-40B4-BE49-F238E27FC236}">
                        <a16:creationId xmlns:a16="http://schemas.microsoft.com/office/drawing/2014/main" id="{A70ED3FE-0303-FA40-B76F-841D99106D51}"/>
                      </a:ext>
                    </a:extLst>
                  </p:cNvPr>
                  <p:cNvCxnSpPr/>
                  <p:nvPr/>
                </p:nvCxnSpPr>
                <p:spPr>
                  <a:xfrm>
                    <a:off x="3928179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" name="直線コネクタ 110">
                    <a:extLst>
                      <a:ext uri="{FF2B5EF4-FFF2-40B4-BE49-F238E27FC236}">
                        <a16:creationId xmlns:a16="http://schemas.microsoft.com/office/drawing/2014/main" id="{5C82C57F-9970-5547-BEB2-52676478A9B1}"/>
                      </a:ext>
                    </a:extLst>
                  </p:cNvPr>
                  <p:cNvCxnSpPr/>
                  <p:nvPr/>
                </p:nvCxnSpPr>
                <p:spPr>
                  <a:xfrm>
                    <a:off x="4576745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" name="直線コネクタ 111">
                    <a:extLst>
                      <a:ext uri="{FF2B5EF4-FFF2-40B4-BE49-F238E27FC236}">
                        <a16:creationId xmlns:a16="http://schemas.microsoft.com/office/drawing/2014/main" id="{CE8D3295-6D5E-E741-89CF-F9E2D29E6C9B}"/>
                      </a:ext>
                    </a:extLst>
                  </p:cNvPr>
                  <p:cNvCxnSpPr/>
                  <p:nvPr/>
                </p:nvCxnSpPr>
                <p:spPr>
                  <a:xfrm>
                    <a:off x="5225312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" name="直線コネクタ 112">
                    <a:extLst>
                      <a:ext uri="{FF2B5EF4-FFF2-40B4-BE49-F238E27FC236}">
                        <a16:creationId xmlns:a16="http://schemas.microsoft.com/office/drawing/2014/main" id="{685AD39E-074F-F447-BB3C-A83247FDD9A7}"/>
                      </a:ext>
                    </a:extLst>
                  </p:cNvPr>
                  <p:cNvCxnSpPr/>
                  <p:nvPr/>
                </p:nvCxnSpPr>
                <p:spPr>
                  <a:xfrm>
                    <a:off x="65224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" name="直線コネクタ 113">
                    <a:extLst>
                      <a:ext uri="{FF2B5EF4-FFF2-40B4-BE49-F238E27FC236}">
                        <a16:creationId xmlns:a16="http://schemas.microsoft.com/office/drawing/2014/main" id="{B3B756C2-7834-F44C-A438-EDD2A42EEDB2}"/>
                      </a:ext>
                    </a:extLst>
                  </p:cNvPr>
                  <p:cNvCxnSpPr/>
                  <p:nvPr/>
                </p:nvCxnSpPr>
                <p:spPr>
                  <a:xfrm>
                    <a:off x="5873878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5" name="直線コネクタ 114">
                    <a:extLst>
                      <a:ext uri="{FF2B5EF4-FFF2-40B4-BE49-F238E27FC236}">
                        <a16:creationId xmlns:a16="http://schemas.microsoft.com/office/drawing/2014/main" id="{1B442A68-E876-8046-B70B-7A7D6259B5B0}"/>
                      </a:ext>
                    </a:extLst>
                  </p:cNvPr>
                  <p:cNvCxnSpPr/>
                  <p:nvPr/>
                </p:nvCxnSpPr>
                <p:spPr>
                  <a:xfrm>
                    <a:off x="7171010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" name="直線コネクタ 115">
                    <a:extLst>
                      <a:ext uri="{FF2B5EF4-FFF2-40B4-BE49-F238E27FC236}">
                        <a16:creationId xmlns:a16="http://schemas.microsoft.com/office/drawing/2014/main" id="{91D5EAAA-655F-EC4C-80CF-EF1EDF876F1B}"/>
                      </a:ext>
                    </a:extLst>
                  </p:cNvPr>
                  <p:cNvCxnSpPr/>
                  <p:nvPr/>
                </p:nvCxnSpPr>
                <p:spPr>
                  <a:xfrm>
                    <a:off x="84681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" name="直線コネクタ 116">
                    <a:extLst>
                      <a:ext uri="{FF2B5EF4-FFF2-40B4-BE49-F238E27FC236}">
                        <a16:creationId xmlns:a16="http://schemas.microsoft.com/office/drawing/2014/main" id="{D269B8FD-8E3F-5D4B-A828-00EB7BA4B733}"/>
                      </a:ext>
                    </a:extLst>
                  </p:cNvPr>
                  <p:cNvCxnSpPr/>
                  <p:nvPr/>
                </p:nvCxnSpPr>
                <p:spPr>
                  <a:xfrm>
                    <a:off x="7819576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00" name="グループ化 99">
                  <a:extLst>
                    <a:ext uri="{FF2B5EF4-FFF2-40B4-BE49-F238E27FC236}">
                      <a16:creationId xmlns:a16="http://schemas.microsoft.com/office/drawing/2014/main" id="{A277CB40-599B-5A41-86EA-F7461D41B891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104215" cy="3510752"/>
                  <a:chOff x="1878266" y="783771"/>
                  <a:chExt cx="104215" cy="3510752"/>
                </a:xfrm>
              </p:grpSpPr>
              <p:cxnSp>
                <p:nvCxnSpPr>
                  <p:cNvPr id="101" name="直線コネクタ 100">
                    <a:extLst>
                      <a:ext uri="{FF2B5EF4-FFF2-40B4-BE49-F238E27FC236}">
                        <a16:creationId xmlns:a16="http://schemas.microsoft.com/office/drawing/2014/main" id="{EEC68E71-7EDA-464A-A7FF-CA76426BBE59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783771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" name="直線コネクタ 101">
                    <a:extLst>
                      <a:ext uri="{FF2B5EF4-FFF2-40B4-BE49-F238E27FC236}">
                        <a16:creationId xmlns:a16="http://schemas.microsoft.com/office/drawing/2014/main" id="{5D25ADE8-1C23-3E4D-BB8A-DA6A523C2B77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1661459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" name="直線コネクタ 102">
                    <a:extLst>
                      <a:ext uri="{FF2B5EF4-FFF2-40B4-BE49-F238E27FC236}">
                        <a16:creationId xmlns:a16="http://schemas.microsoft.com/office/drawing/2014/main" id="{68B57748-B733-7A4C-9BAC-0749E013D176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2539147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4" name="直線コネクタ 103">
                    <a:extLst>
                      <a:ext uri="{FF2B5EF4-FFF2-40B4-BE49-F238E27FC236}">
                        <a16:creationId xmlns:a16="http://schemas.microsoft.com/office/drawing/2014/main" id="{E12C5591-F3F4-E844-881B-73D22D449CC6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4294523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" name="直線コネクタ 104">
                    <a:extLst>
                      <a:ext uri="{FF2B5EF4-FFF2-40B4-BE49-F238E27FC236}">
                        <a16:creationId xmlns:a16="http://schemas.microsoft.com/office/drawing/2014/main" id="{4133175A-8DE6-2043-9643-3F379236E66B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3416835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92" name="グループ化 91">
                <a:extLst>
                  <a:ext uri="{FF2B5EF4-FFF2-40B4-BE49-F238E27FC236}">
                    <a16:creationId xmlns:a16="http://schemas.microsoft.com/office/drawing/2014/main" id="{5C2AAB94-E2E9-BB4C-8DBA-5AFCB730FA7F}"/>
                  </a:ext>
                </a:extLst>
              </p:cNvPr>
              <p:cNvGrpSpPr/>
              <p:nvPr/>
            </p:nvGrpSpPr>
            <p:grpSpPr>
              <a:xfrm>
                <a:off x="1587536" y="5875641"/>
                <a:ext cx="8165961" cy="369333"/>
                <a:chOff x="-18297497" y="9356492"/>
                <a:chExt cx="16311128" cy="737728"/>
              </a:xfrm>
            </p:grpSpPr>
            <p:sp>
              <p:nvSpPr>
                <p:cNvPr id="93" name="テキスト ボックス 92">
                  <a:extLst>
                    <a:ext uri="{FF2B5EF4-FFF2-40B4-BE49-F238E27FC236}">
                      <a16:creationId xmlns:a16="http://schemas.microsoft.com/office/drawing/2014/main" id="{4B5104E2-2980-584A-A5A1-7FD1DD80D84F}"/>
                    </a:ext>
                  </a:extLst>
                </p:cNvPr>
                <p:cNvSpPr txBox="1"/>
                <p:nvPr/>
              </p:nvSpPr>
              <p:spPr>
                <a:xfrm>
                  <a:off x="-18297497" y="9356494"/>
                  <a:ext cx="1496141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D4B598C1-6725-5E41-A301-541347AC1704}"/>
                    </a:ext>
                  </a:extLst>
                </p:cNvPr>
                <p:cNvSpPr txBox="1"/>
                <p:nvPr/>
              </p:nvSpPr>
              <p:spPr>
                <a:xfrm>
                  <a:off x="-15535035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テキスト ボックス 94">
                  <a:extLst>
                    <a:ext uri="{FF2B5EF4-FFF2-40B4-BE49-F238E27FC236}">
                      <a16:creationId xmlns:a16="http://schemas.microsoft.com/office/drawing/2014/main" id="{A2CC745B-5223-C14B-B0EB-A11C91890A84}"/>
                    </a:ext>
                  </a:extLst>
                </p:cNvPr>
                <p:cNvSpPr txBox="1"/>
                <p:nvPr/>
              </p:nvSpPr>
              <p:spPr>
                <a:xfrm>
                  <a:off x="-12539084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" name="テキスト ボックス 95">
                  <a:extLst>
                    <a:ext uri="{FF2B5EF4-FFF2-40B4-BE49-F238E27FC236}">
                      <a16:creationId xmlns:a16="http://schemas.microsoft.com/office/drawing/2014/main" id="{A56A9EC3-E4BF-324F-BA85-86EA86BC0DD5}"/>
                    </a:ext>
                  </a:extLst>
                </p:cNvPr>
                <p:cNvSpPr txBox="1"/>
                <p:nvPr/>
              </p:nvSpPr>
              <p:spPr>
                <a:xfrm>
                  <a:off x="-9650916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テキスト ボックス 96">
                  <a:extLst>
                    <a:ext uri="{FF2B5EF4-FFF2-40B4-BE49-F238E27FC236}">
                      <a16:creationId xmlns:a16="http://schemas.microsoft.com/office/drawing/2014/main" id="{CE38748C-7D8B-0B46-9159-03490A37A990}"/>
                    </a:ext>
                  </a:extLst>
                </p:cNvPr>
                <p:cNvSpPr txBox="1"/>
                <p:nvPr/>
              </p:nvSpPr>
              <p:spPr>
                <a:xfrm>
                  <a:off x="-6762748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テキスト ボックス 97">
                  <a:extLst>
                    <a:ext uri="{FF2B5EF4-FFF2-40B4-BE49-F238E27FC236}">
                      <a16:creationId xmlns:a16="http://schemas.microsoft.com/office/drawing/2014/main" id="{60B72193-FB5D-B844-871C-DFECEC62D94E}"/>
                    </a:ext>
                  </a:extLst>
                </p:cNvPr>
                <p:cNvSpPr txBox="1"/>
                <p:nvPr/>
              </p:nvSpPr>
              <p:spPr>
                <a:xfrm>
                  <a:off x="-3799747" y="9356492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B29441C6-483A-BA49-83DA-E302D82B901D}"/>
                </a:ext>
              </a:extLst>
            </p:cNvPr>
            <p:cNvSpPr txBox="1"/>
            <p:nvPr/>
          </p:nvSpPr>
          <p:spPr>
            <a:xfrm>
              <a:off x="1198823" y="559386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7C993A01-774C-C947-9FEB-AE7EC99A9922}"/>
                </a:ext>
              </a:extLst>
            </p:cNvPr>
            <p:cNvSpPr txBox="1"/>
            <p:nvPr/>
          </p:nvSpPr>
          <p:spPr>
            <a:xfrm>
              <a:off x="1198823" y="1549631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DA4F2BB2-FDE4-6A4B-9EC7-16CD7F994281}"/>
                </a:ext>
              </a:extLst>
            </p:cNvPr>
            <p:cNvSpPr txBox="1"/>
            <p:nvPr/>
          </p:nvSpPr>
          <p:spPr>
            <a:xfrm>
              <a:off x="1198696" y="2539878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B3A9C458-C60D-5E47-B629-DE1A69D6BAA5}"/>
                </a:ext>
              </a:extLst>
            </p:cNvPr>
            <p:cNvSpPr txBox="1"/>
            <p:nvPr/>
          </p:nvSpPr>
          <p:spPr>
            <a:xfrm>
              <a:off x="1198696" y="3530123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F5AC6C4C-A5F0-AE40-8FA9-9B28B60546DC}"/>
                </a:ext>
              </a:extLst>
            </p:cNvPr>
            <p:cNvSpPr txBox="1"/>
            <p:nvPr/>
          </p:nvSpPr>
          <p:spPr>
            <a:xfrm>
              <a:off x="1198696" y="4551111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62A99949-95A5-7247-8684-2B5562591A24}"/>
                </a:ext>
              </a:extLst>
            </p:cNvPr>
            <p:cNvSpPr txBox="1"/>
            <p:nvPr/>
          </p:nvSpPr>
          <p:spPr>
            <a:xfrm>
              <a:off x="1198696" y="5541356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7D52E0AD-8764-BF41-A619-B9823C66A7C8}"/>
              </a:ext>
            </a:extLst>
          </p:cNvPr>
          <p:cNvSpPr txBox="1"/>
          <p:nvPr/>
        </p:nvSpPr>
        <p:spPr>
          <a:xfrm>
            <a:off x="4746649" y="6129338"/>
            <a:ext cx="253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0" name="表 2">
            <a:extLst>
              <a:ext uri="{FF2B5EF4-FFF2-40B4-BE49-F238E27FC236}">
                <a16:creationId xmlns:a16="http://schemas.microsoft.com/office/drawing/2014/main" id="{6B335E97-C98B-DE4A-A8F8-B1948CC7D5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594338"/>
              </p:ext>
            </p:extLst>
          </p:nvPr>
        </p:nvGraphicFramePr>
        <p:xfrm>
          <a:off x="4764813" y="744052"/>
          <a:ext cx="4790480" cy="2072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97620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1197620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  <a:gridCol w="1197620">
                  <a:extLst>
                    <a:ext uri="{9D8B030D-6E8A-4147-A177-3AD203B41FA5}">
                      <a16:colId xmlns:a16="http://schemas.microsoft.com/office/drawing/2014/main" val="2774130465"/>
                    </a:ext>
                  </a:extLst>
                </a:gridCol>
                <a:gridCol w="1197620">
                  <a:extLst>
                    <a:ext uri="{9D8B030D-6E8A-4147-A177-3AD203B41FA5}">
                      <a16:colId xmlns:a16="http://schemas.microsoft.com/office/drawing/2014/main" val="1774716991"/>
                    </a:ext>
                  </a:extLst>
                </a:gridCol>
              </a:tblGrid>
              <a:tr h="485361">
                <a:tc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zard ratio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CI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79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5528354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rate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54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1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2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–2.99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5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  <a:tr h="33710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r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14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7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8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8–4.85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3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114148"/>
                  </a:ext>
                </a:extLst>
              </a:tr>
            </a:tbl>
          </a:graphicData>
        </a:graphic>
      </p:graphicFrame>
      <p:grpSp>
        <p:nvGrpSpPr>
          <p:cNvPr id="122" name="グループ化 121">
            <a:extLst>
              <a:ext uri="{FF2B5EF4-FFF2-40B4-BE49-F238E27FC236}">
                <a16:creationId xmlns:a16="http://schemas.microsoft.com/office/drawing/2014/main" id="{9318DA88-0D27-F04D-AD88-BEA4AABD1B76}"/>
              </a:ext>
            </a:extLst>
          </p:cNvPr>
          <p:cNvGrpSpPr/>
          <p:nvPr/>
        </p:nvGrpSpPr>
        <p:grpSpPr>
          <a:xfrm>
            <a:off x="10288285" y="554031"/>
            <a:ext cx="8554801" cy="5685588"/>
            <a:chOff x="1198696" y="559386"/>
            <a:chExt cx="8554801" cy="5685588"/>
          </a:xfrm>
        </p:grpSpPr>
        <p:grpSp>
          <p:nvGrpSpPr>
            <p:cNvPr id="123" name="グループ化 122">
              <a:extLst>
                <a:ext uri="{FF2B5EF4-FFF2-40B4-BE49-F238E27FC236}">
                  <a16:creationId xmlns:a16="http://schemas.microsoft.com/office/drawing/2014/main" id="{33255EA9-86F7-D843-8A7E-FDC22B87CA07}"/>
                </a:ext>
              </a:extLst>
            </p:cNvPr>
            <p:cNvGrpSpPr/>
            <p:nvPr/>
          </p:nvGrpSpPr>
          <p:grpSpPr>
            <a:xfrm>
              <a:off x="1587536" y="728662"/>
              <a:ext cx="8165961" cy="5516312"/>
              <a:chOff x="1587536" y="728662"/>
              <a:chExt cx="8165961" cy="5516312"/>
            </a:xfrm>
          </p:grpSpPr>
          <p:grpSp>
            <p:nvGrpSpPr>
              <p:cNvPr id="130" name="グループ化 129">
                <a:extLst>
                  <a:ext uri="{FF2B5EF4-FFF2-40B4-BE49-F238E27FC236}">
                    <a16:creationId xmlns:a16="http://schemas.microsoft.com/office/drawing/2014/main" id="{290F08DF-7BDB-9149-9137-D4A0975D823B}"/>
                  </a:ext>
                </a:extLst>
              </p:cNvPr>
              <p:cNvGrpSpPr/>
              <p:nvPr/>
            </p:nvGrpSpPr>
            <p:grpSpPr>
              <a:xfrm>
                <a:off x="1856217" y="728662"/>
                <a:ext cx="7699076" cy="5100637"/>
                <a:chOff x="1878266" y="783771"/>
                <a:chExt cx="6812280" cy="4520862"/>
              </a:xfrm>
            </p:grpSpPr>
            <p:grpSp>
              <p:nvGrpSpPr>
                <p:cNvPr id="138" name="グループ化 137">
                  <a:extLst>
                    <a:ext uri="{FF2B5EF4-FFF2-40B4-BE49-F238E27FC236}">
                      <a16:creationId xmlns:a16="http://schemas.microsoft.com/office/drawing/2014/main" id="{966839DB-020B-F540-8CFC-5E8941AAD1A0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6812280" cy="4520862"/>
                  <a:chOff x="1878266" y="776087"/>
                  <a:chExt cx="6812280" cy="4520862"/>
                </a:xfrm>
              </p:grpSpPr>
              <p:cxnSp>
                <p:nvCxnSpPr>
                  <p:cNvPr id="145" name="直線コネクタ 144">
                    <a:extLst>
                      <a:ext uri="{FF2B5EF4-FFF2-40B4-BE49-F238E27FC236}">
                        <a16:creationId xmlns:a16="http://schemas.microsoft.com/office/drawing/2014/main" id="{518C091E-3D6A-5F40-9E7B-3349C6811C3D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5170949"/>
                    <a:ext cx="681228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直線コネクタ 145">
                    <a:extLst>
                      <a:ext uri="{FF2B5EF4-FFF2-40B4-BE49-F238E27FC236}">
                        <a16:creationId xmlns:a16="http://schemas.microsoft.com/office/drawing/2014/main" id="{CDFBA837-F2D6-8240-9782-EB893BA417C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2481" y="776087"/>
                    <a:ext cx="0" cy="45208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7" name="直線コネクタ 146">
                    <a:extLst>
                      <a:ext uri="{FF2B5EF4-FFF2-40B4-BE49-F238E27FC236}">
                        <a16:creationId xmlns:a16="http://schemas.microsoft.com/office/drawing/2014/main" id="{6FB9E78C-2445-934F-B5E5-AA3D462F0DEA}"/>
                      </a:ext>
                    </a:extLst>
                  </p:cNvPr>
                  <p:cNvCxnSpPr/>
                  <p:nvPr/>
                </p:nvCxnSpPr>
                <p:spPr>
                  <a:xfrm>
                    <a:off x="2631047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8" name="直線コネクタ 147">
                    <a:extLst>
                      <a:ext uri="{FF2B5EF4-FFF2-40B4-BE49-F238E27FC236}">
                        <a16:creationId xmlns:a16="http://schemas.microsoft.com/office/drawing/2014/main" id="{C2EC8B00-CFA2-274B-868A-C7877C547DBE}"/>
                      </a:ext>
                    </a:extLst>
                  </p:cNvPr>
                  <p:cNvCxnSpPr/>
                  <p:nvPr/>
                </p:nvCxnSpPr>
                <p:spPr>
                  <a:xfrm>
                    <a:off x="3279613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9" name="直線コネクタ 148">
                    <a:extLst>
                      <a:ext uri="{FF2B5EF4-FFF2-40B4-BE49-F238E27FC236}">
                        <a16:creationId xmlns:a16="http://schemas.microsoft.com/office/drawing/2014/main" id="{2DD966C9-49EB-8545-9325-C04084117992}"/>
                      </a:ext>
                    </a:extLst>
                  </p:cNvPr>
                  <p:cNvCxnSpPr/>
                  <p:nvPr/>
                </p:nvCxnSpPr>
                <p:spPr>
                  <a:xfrm>
                    <a:off x="3928179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0" name="直線コネクタ 149">
                    <a:extLst>
                      <a:ext uri="{FF2B5EF4-FFF2-40B4-BE49-F238E27FC236}">
                        <a16:creationId xmlns:a16="http://schemas.microsoft.com/office/drawing/2014/main" id="{F06C15BA-B459-594E-AAE9-C0C5548E04C7}"/>
                      </a:ext>
                    </a:extLst>
                  </p:cNvPr>
                  <p:cNvCxnSpPr/>
                  <p:nvPr/>
                </p:nvCxnSpPr>
                <p:spPr>
                  <a:xfrm>
                    <a:off x="4576745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1" name="直線コネクタ 150">
                    <a:extLst>
                      <a:ext uri="{FF2B5EF4-FFF2-40B4-BE49-F238E27FC236}">
                        <a16:creationId xmlns:a16="http://schemas.microsoft.com/office/drawing/2014/main" id="{AB441DD6-86A8-8145-B1B6-3397309EF3D4}"/>
                      </a:ext>
                    </a:extLst>
                  </p:cNvPr>
                  <p:cNvCxnSpPr/>
                  <p:nvPr/>
                </p:nvCxnSpPr>
                <p:spPr>
                  <a:xfrm>
                    <a:off x="5225312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2" name="直線コネクタ 151">
                    <a:extLst>
                      <a:ext uri="{FF2B5EF4-FFF2-40B4-BE49-F238E27FC236}">
                        <a16:creationId xmlns:a16="http://schemas.microsoft.com/office/drawing/2014/main" id="{E2575895-904D-274D-A8EF-6946AF151FD1}"/>
                      </a:ext>
                    </a:extLst>
                  </p:cNvPr>
                  <p:cNvCxnSpPr/>
                  <p:nvPr/>
                </p:nvCxnSpPr>
                <p:spPr>
                  <a:xfrm>
                    <a:off x="65224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3" name="直線コネクタ 152">
                    <a:extLst>
                      <a:ext uri="{FF2B5EF4-FFF2-40B4-BE49-F238E27FC236}">
                        <a16:creationId xmlns:a16="http://schemas.microsoft.com/office/drawing/2014/main" id="{42597FDF-F70B-7942-BA55-03BA918D713C}"/>
                      </a:ext>
                    </a:extLst>
                  </p:cNvPr>
                  <p:cNvCxnSpPr/>
                  <p:nvPr/>
                </p:nvCxnSpPr>
                <p:spPr>
                  <a:xfrm>
                    <a:off x="5873878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4" name="直線コネクタ 153">
                    <a:extLst>
                      <a:ext uri="{FF2B5EF4-FFF2-40B4-BE49-F238E27FC236}">
                        <a16:creationId xmlns:a16="http://schemas.microsoft.com/office/drawing/2014/main" id="{DDF5AEB3-1A08-8942-ABF4-143A8A291F35}"/>
                      </a:ext>
                    </a:extLst>
                  </p:cNvPr>
                  <p:cNvCxnSpPr/>
                  <p:nvPr/>
                </p:nvCxnSpPr>
                <p:spPr>
                  <a:xfrm>
                    <a:off x="7171010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5" name="直線コネクタ 154">
                    <a:extLst>
                      <a:ext uri="{FF2B5EF4-FFF2-40B4-BE49-F238E27FC236}">
                        <a16:creationId xmlns:a16="http://schemas.microsoft.com/office/drawing/2014/main" id="{08F99C4C-6C4B-2241-B049-16E5750E4967}"/>
                      </a:ext>
                    </a:extLst>
                  </p:cNvPr>
                  <p:cNvCxnSpPr/>
                  <p:nvPr/>
                </p:nvCxnSpPr>
                <p:spPr>
                  <a:xfrm>
                    <a:off x="84681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6" name="直線コネクタ 155">
                    <a:extLst>
                      <a:ext uri="{FF2B5EF4-FFF2-40B4-BE49-F238E27FC236}">
                        <a16:creationId xmlns:a16="http://schemas.microsoft.com/office/drawing/2014/main" id="{13178EE7-F237-F74A-BF09-6B3660774A3E}"/>
                      </a:ext>
                    </a:extLst>
                  </p:cNvPr>
                  <p:cNvCxnSpPr/>
                  <p:nvPr/>
                </p:nvCxnSpPr>
                <p:spPr>
                  <a:xfrm>
                    <a:off x="7819576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9" name="グループ化 138">
                  <a:extLst>
                    <a:ext uri="{FF2B5EF4-FFF2-40B4-BE49-F238E27FC236}">
                      <a16:creationId xmlns:a16="http://schemas.microsoft.com/office/drawing/2014/main" id="{28D77BA7-F07A-0947-BC8C-CE77F9B88FDD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104215" cy="3510752"/>
                  <a:chOff x="1878266" y="783771"/>
                  <a:chExt cx="104215" cy="3510752"/>
                </a:xfrm>
              </p:grpSpPr>
              <p:cxnSp>
                <p:nvCxnSpPr>
                  <p:cNvPr id="140" name="直線コネクタ 139">
                    <a:extLst>
                      <a:ext uri="{FF2B5EF4-FFF2-40B4-BE49-F238E27FC236}">
                        <a16:creationId xmlns:a16="http://schemas.microsoft.com/office/drawing/2014/main" id="{FBAF95F1-4583-7049-A054-D69832188DC0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783771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1" name="直線コネクタ 140">
                    <a:extLst>
                      <a:ext uri="{FF2B5EF4-FFF2-40B4-BE49-F238E27FC236}">
                        <a16:creationId xmlns:a16="http://schemas.microsoft.com/office/drawing/2014/main" id="{2C5B872F-2D07-D34F-9244-5D02AF02A8C5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1661459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" name="直線コネクタ 141">
                    <a:extLst>
                      <a:ext uri="{FF2B5EF4-FFF2-40B4-BE49-F238E27FC236}">
                        <a16:creationId xmlns:a16="http://schemas.microsoft.com/office/drawing/2014/main" id="{FF86E0F4-1026-8643-8267-6E797979EE51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2539147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" name="直線コネクタ 142">
                    <a:extLst>
                      <a:ext uri="{FF2B5EF4-FFF2-40B4-BE49-F238E27FC236}">
                        <a16:creationId xmlns:a16="http://schemas.microsoft.com/office/drawing/2014/main" id="{24EAE641-8A5A-074E-997B-DEA02B412EB0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4294523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" name="直線コネクタ 143">
                    <a:extLst>
                      <a:ext uri="{FF2B5EF4-FFF2-40B4-BE49-F238E27FC236}">
                        <a16:creationId xmlns:a16="http://schemas.microsoft.com/office/drawing/2014/main" id="{E6452348-BD74-E14F-BCCA-318E2CDB71C1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3416835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31" name="グループ化 130">
                <a:extLst>
                  <a:ext uri="{FF2B5EF4-FFF2-40B4-BE49-F238E27FC236}">
                    <a16:creationId xmlns:a16="http://schemas.microsoft.com/office/drawing/2014/main" id="{0BB9F568-F7F5-4944-B6C9-44AC7DC15756}"/>
                  </a:ext>
                </a:extLst>
              </p:cNvPr>
              <p:cNvGrpSpPr/>
              <p:nvPr/>
            </p:nvGrpSpPr>
            <p:grpSpPr>
              <a:xfrm>
                <a:off x="1587536" y="5875641"/>
                <a:ext cx="8165961" cy="369333"/>
                <a:chOff x="-18297497" y="9356492"/>
                <a:chExt cx="16311128" cy="737728"/>
              </a:xfrm>
            </p:grpSpPr>
            <p:sp>
              <p:nvSpPr>
                <p:cNvPr id="132" name="テキスト ボックス 131">
                  <a:extLst>
                    <a:ext uri="{FF2B5EF4-FFF2-40B4-BE49-F238E27FC236}">
                      <a16:creationId xmlns:a16="http://schemas.microsoft.com/office/drawing/2014/main" id="{64C9A3C2-5DE9-E44D-89E1-521DE3918915}"/>
                    </a:ext>
                  </a:extLst>
                </p:cNvPr>
                <p:cNvSpPr txBox="1"/>
                <p:nvPr/>
              </p:nvSpPr>
              <p:spPr>
                <a:xfrm>
                  <a:off x="-18297497" y="9356494"/>
                  <a:ext cx="1496141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テキスト ボックス 132">
                  <a:extLst>
                    <a:ext uri="{FF2B5EF4-FFF2-40B4-BE49-F238E27FC236}">
                      <a16:creationId xmlns:a16="http://schemas.microsoft.com/office/drawing/2014/main" id="{361B6E89-0457-2844-92DA-2225E297C1C0}"/>
                    </a:ext>
                  </a:extLst>
                </p:cNvPr>
                <p:cNvSpPr txBox="1"/>
                <p:nvPr/>
              </p:nvSpPr>
              <p:spPr>
                <a:xfrm>
                  <a:off x="-15535035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テキスト ボックス 133">
                  <a:extLst>
                    <a:ext uri="{FF2B5EF4-FFF2-40B4-BE49-F238E27FC236}">
                      <a16:creationId xmlns:a16="http://schemas.microsoft.com/office/drawing/2014/main" id="{1A80A7D9-B436-5045-B3E5-4796B657C0C4}"/>
                    </a:ext>
                  </a:extLst>
                </p:cNvPr>
                <p:cNvSpPr txBox="1"/>
                <p:nvPr/>
              </p:nvSpPr>
              <p:spPr>
                <a:xfrm>
                  <a:off x="-12539084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テキスト ボックス 134">
                  <a:extLst>
                    <a:ext uri="{FF2B5EF4-FFF2-40B4-BE49-F238E27FC236}">
                      <a16:creationId xmlns:a16="http://schemas.microsoft.com/office/drawing/2014/main" id="{70FBED1D-3337-D246-814E-7AEA65F7AC61}"/>
                    </a:ext>
                  </a:extLst>
                </p:cNvPr>
                <p:cNvSpPr txBox="1"/>
                <p:nvPr/>
              </p:nvSpPr>
              <p:spPr>
                <a:xfrm>
                  <a:off x="-9650916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テキスト ボックス 135">
                  <a:extLst>
                    <a:ext uri="{FF2B5EF4-FFF2-40B4-BE49-F238E27FC236}">
                      <a16:creationId xmlns:a16="http://schemas.microsoft.com/office/drawing/2014/main" id="{776B7D54-8596-5D40-B4DB-DF585A60A07B}"/>
                    </a:ext>
                  </a:extLst>
                </p:cNvPr>
                <p:cNvSpPr txBox="1"/>
                <p:nvPr/>
              </p:nvSpPr>
              <p:spPr>
                <a:xfrm>
                  <a:off x="-6762748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テキスト ボックス 136">
                  <a:extLst>
                    <a:ext uri="{FF2B5EF4-FFF2-40B4-BE49-F238E27FC236}">
                      <a16:creationId xmlns:a16="http://schemas.microsoft.com/office/drawing/2014/main" id="{089B1D33-08B8-D545-8EA3-57F8D811D881}"/>
                    </a:ext>
                  </a:extLst>
                </p:cNvPr>
                <p:cNvSpPr txBox="1"/>
                <p:nvPr/>
              </p:nvSpPr>
              <p:spPr>
                <a:xfrm>
                  <a:off x="-3799747" y="9356492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BB842B4F-BECD-CB4D-A9B8-80A253006F93}"/>
                </a:ext>
              </a:extLst>
            </p:cNvPr>
            <p:cNvSpPr txBox="1"/>
            <p:nvPr/>
          </p:nvSpPr>
          <p:spPr>
            <a:xfrm>
              <a:off x="1198823" y="559386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F5EEC559-882F-274D-A19D-D048C81E6D90}"/>
                </a:ext>
              </a:extLst>
            </p:cNvPr>
            <p:cNvSpPr txBox="1"/>
            <p:nvPr/>
          </p:nvSpPr>
          <p:spPr>
            <a:xfrm>
              <a:off x="1198823" y="1549631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9FD9B371-3B59-8240-9819-0CAC09596E26}"/>
                </a:ext>
              </a:extLst>
            </p:cNvPr>
            <p:cNvSpPr txBox="1"/>
            <p:nvPr/>
          </p:nvSpPr>
          <p:spPr>
            <a:xfrm>
              <a:off x="1198696" y="2539878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A4DA7625-387A-814A-A971-CF712FC78827}"/>
                </a:ext>
              </a:extLst>
            </p:cNvPr>
            <p:cNvSpPr txBox="1"/>
            <p:nvPr/>
          </p:nvSpPr>
          <p:spPr>
            <a:xfrm>
              <a:off x="1198696" y="3530123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98C38543-0F47-B64A-B496-E18ED329948B}"/>
                </a:ext>
              </a:extLst>
            </p:cNvPr>
            <p:cNvSpPr txBox="1"/>
            <p:nvPr/>
          </p:nvSpPr>
          <p:spPr>
            <a:xfrm>
              <a:off x="1198696" y="4551111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FAD36F52-2277-4E43-B156-0516F6EE792E}"/>
                </a:ext>
              </a:extLst>
            </p:cNvPr>
            <p:cNvSpPr txBox="1"/>
            <p:nvPr/>
          </p:nvSpPr>
          <p:spPr>
            <a:xfrm>
              <a:off x="1198696" y="5541356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72567F8A-BA22-4A4A-8CD3-70BB273685B1}"/>
              </a:ext>
            </a:extLst>
          </p:cNvPr>
          <p:cNvSpPr txBox="1"/>
          <p:nvPr/>
        </p:nvSpPr>
        <p:spPr>
          <a:xfrm>
            <a:off x="13836238" y="6123983"/>
            <a:ext cx="253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9" name="表 2">
            <a:extLst>
              <a:ext uri="{FF2B5EF4-FFF2-40B4-BE49-F238E27FC236}">
                <a16:creationId xmlns:a16="http://schemas.microsoft.com/office/drawing/2014/main" id="{CAF42A21-E7F8-7A40-8704-206A400AEF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8688201"/>
              </p:ext>
            </p:extLst>
          </p:nvPr>
        </p:nvGraphicFramePr>
        <p:xfrm>
          <a:off x="13598683" y="744052"/>
          <a:ext cx="4790480" cy="2072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97620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1197620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  <a:gridCol w="1197620">
                  <a:extLst>
                    <a:ext uri="{9D8B030D-6E8A-4147-A177-3AD203B41FA5}">
                      <a16:colId xmlns:a16="http://schemas.microsoft.com/office/drawing/2014/main" val="2774130465"/>
                    </a:ext>
                  </a:extLst>
                </a:gridCol>
                <a:gridCol w="1197620">
                  <a:extLst>
                    <a:ext uri="{9D8B030D-6E8A-4147-A177-3AD203B41FA5}">
                      <a16:colId xmlns:a16="http://schemas.microsoft.com/office/drawing/2014/main" val="1774716991"/>
                    </a:ext>
                  </a:extLst>
                </a:gridCol>
              </a:tblGrid>
              <a:tr h="485361">
                <a:tc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zard ratio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CI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223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7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5528354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rate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181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–2.00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r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38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0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3–3.60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114148"/>
                  </a:ext>
                </a:extLst>
              </a:tr>
            </a:tbl>
          </a:graphicData>
        </a:graphic>
      </p:graphicFrame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5AFEE598-668A-1E48-9B8F-F5EC7AFBA915}"/>
              </a:ext>
            </a:extLst>
          </p:cNvPr>
          <p:cNvSpPr txBox="1"/>
          <p:nvPr/>
        </p:nvSpPr>
        <p:spPr>
          <a:xfrm rot="16200000">
            <a:off x="219814" y="3059616"/>
            <a:ext cx="1872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A96D4319-11B3-7E47-A6C9-AEB774B330C5}"/>
              </a:ext>
            </a:extLst>
          </p:cNvPr>
          <p:cNvSpPr txBox="1"/>
          <p:nvPr/>
        </p:nvSpPr>
        <p:spPr>
          <a:xfrm rot="16200000">
            <a:off x="9185782" y="3059617"/>
            <a:ext cx="1872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277040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BRACELET Study 1">
      <a:dk1>
        <a:srgbClr val="000000"/>
      </a:dk1>
      <a:lt1>
        <a:srgbClr val="FFFFFF"/>
      </a:lt1>
      <a:dk2>
        <a:srgbClr val="454551"/>
      </a:dk2>
      <a:lt2>
        <a:srgbClr val="D8D9DC"/>
      </a:lt2>
      <a:accent1>
        <a:srgbClr val="E8003E"/>
      </a:accent1>
      <a:accent2>
        <a:srgbClr val="C830CC"/>
      </a:accent2>
      <a:accent3>
        <a:srgbClr val="4EA6DC"/>
      </a:accent3>
      <a:accent4>
        <a:srgbClr val="00559B"/>
      </a:accent4>
      <a:accent5>
        <a:srgbClr val="8971E1"/>
      </a:accent5>
      <a:accent6>
        <a:srgbClr val="D54773"/>
      </a:accent6>
      <a:hlink>
        <a:srgbClr val="B30658"/>
      </a:hlink>
      <a:folHlink>
        <a:srgbClr val="00559B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JOG13219G template" id="{C2A2FF71-2FFF-A542-8AB3-4CC5D1F2FF7E}" vid="{84F2038F-6506-2841-81A3-3FBB7B3A4003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18</TotalTime>
  <Words>149</Words>
  <Application>Microsoft Macintosh PowerPoint</Application>
  <PresentationFormat>ユーザー設定</PresentationFormat>
  <Paragraphs>7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游ゴシック</vt:lpstr>
      <vt:lpstr>Arial</vt:lpstr>
      <vt:lpstr>1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下嵜 啓太郎</dc:creator>
  <cp:lastModifiedBy>下嵜啓太郎</cp:lastModifiedBy>
  <cp:revision>215</cp:revision>
  <cp:lastPrinted>2021-03-12T09:49:31Z</cp:lastPrinted>
  <dcterms:created xsi:type="dcterms:W3CDTF">2021-02-06T04:10:30Z</dcterms:created>
  <dcterms:modified xsi:type="dcterms:W3CDTF">2021-06-17T05:55:03Z</dcterms:modified>
</cp:coreProperties>
</file>